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88B399E-BD4D-4E1B-B5A8-280CA2D9D19A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8C28BB-AA54-4616-909D-9EF49B3D8DEB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BE700-1658-4645-AC52-5FB08132DF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09B1B-6544-4261-8C75-EB8B1E8B5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39FAA-A799-4B48-B9E0-FEA544C285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0D1ED-4B50-4BCC-BCBC-EB1B11D6AC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8D062-6ADC-4A25-975E-E837476E55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7A8EF-D3CD-4022-95A2-DEE67B80D2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7EFA6-1AB8-40D1-A7F4-E1865054EF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B260C-009F-4591-A1FF-83412C0C52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CE0EC-5028-4B0A-9E59-515300AFF8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7430E-E33C-4A29-9972-2DD22A7484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D2FB6-0937-44D0-90ED-D827BC5768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DDCD2-5FF6-40ED-AB37-71C5D2F62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7F9774-710C-4ED8-83A9-84F502851338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826920" y="152280"/>
            <a:ext cx="3594240" cy="27054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tretch/>
        </p:blipFill>
        <p:spPr>
          <a:xfrm>
            <a:off x="4495680" y="163440"/>
            <a:ext cx="3594240" cy="2694240"/>
          </a:xfrm>
          <a:prstGeom prst="rect">
            <a:avLst/>
          </a:prstGeom>
          <a:ln w="0">
            <a:noFill/>
          </a:ln>
        </p:spPr>
      </p:pic>
      <p:sp>
        <p:nvSpPr>
          <p:cNvPr id="50" name="CasellaDiTesto 7"/>
          <p:cNvSpPr/>
          <p:nvPr/>
        </p:nvSpPr>
        <p:spPr>
          <a:xfrm>
            <a:off x="838080" y="152280"/>
            <a:ext cx="1584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Tg2576 #103, vehic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ttangolo 8"/>
          <p:cNvSpPr/>
          <p:nvPr/>
        </p:nvSpPr>
        <p:spPr>
          <a:xfrm>
            <a:off x="449964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Tg2576 #130,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DAPT60mg/k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11"/>
          <p:cNvSpPr/>
          <p:nvPr/>
        </p:nvSpPr>
        <p:spPr>
          <a:xfrm>
            <a:off x="228600" y="5803920"/>
            <a:ext cx="8458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Arial Narrow"/>
              </a:rPr>
              <a:t>A, B: Representative images of activated microglia (IBA1 immunostaining) of CA1 hippocampal cortex of Tg2576 vehicle (A) and DAPT (B) treated animals. C, D: Representative images of 6E10 immunostaining of cerebral cortex of Tg2576 vehicle (C) and DAPT (D) treated animal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2" descr=""/>
          <p:cNvPicPr/>
          <p:nvPr/>
        </p:nvPicPr>
        <p:blipFill>
          <a:blip r:embed="rId3"/>
          <a:stretch/>
        </p:blipFill>
        <p:spPr>
          <a:xfrm>
            <a:off x="839880" y="2924280"/>
            <a:ext cx="3581280" cy="2638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" descr=""/>
          <p:cNvPicPr/>
          <p:nvPr/>
        </p:nvPicPr>
        <p:blipFill>
          <a:blip r:embed="rId4"/>
          <a:stretch/>
        </p:blipFill>
        <p:spPr>
          <a:xfrm>
            <a:off x="4495680" y="2924280"/>
            <a:ext cx="3581640" cy="2638440"/>
          </a:xfrm>
          <a:prstGeom prst="rect">
            <a:avLst/>
          </a:prstGeom>
          <a:ln w="0">
            <a:noFill/>
          </a:ln>
        </p:spPr>
      </p:pic>
      <p:sp>
        <p:nvSpPr>
          <p:cNvPr id="55" name="CasellaDiTesto 5"/>
          <p:cNvSpPr/>
          <p:nvPr/>
        </p:nvSpPr>
        <p:spPr>
          <a:xfrm>
            <a:off x="838080" y="2940120"/>
            <a:ext cx="1727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Tg2576 #107, vehic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ttangolo 6"/>
          <p:cNvSpPr/>
          <p:nvPr/>
        </p:nvSpPr>
        <p:spPr>
          <a:xfrm>
            <a:off x="4499640" y="294012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Tg2576 #118,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 Narrow"/>
              </a:rPr>
              <a:t>DAPT60mg/k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"/>
          <p:cNvSpPr/>
          <p:nvPr/>
        </p:nvSpPr>
        <p:spPr>
          <a:xfrm>
            <a:off x="824400" y="2529000"/>
            <a:ext cx="401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A.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"/>
          <p:cNvSpPr/>
          <p:nvPr/>
        </p:nvSpPr>
        <p:spPr>
          <a:xfrm>
            <a:off x="839520" y="5181480"/>
            <a:ext cx="402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C.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	</a:t>
            </a:r>
            <a:r>
              <a:rPr b="0" lang="en-GB" sz="1800" spc="-1" strike="noStrike">
                <a:solidFill>
                  <a:srgbClr val="000000"/>
                </a:solidFill>
                <a:latin typeface="Arial Narrow"/>
              </a:rPr>
              <a:t>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1T15:57:48Z</dcterms:created>
  <dc:creator>Prot. Pietrini</dc:creator>
  <dc:description/>
  <dc:language>en-US</dc:language>
  <cp:lastModifiedBy>Laura Calza</cp:lastModifiedBy>
  <dcterms:modified xsi:type="dcterms:W3CDTF">2012-11-29T16:10:51Z</dcterms:modified>
  <cp:revision>12</cp:revision>
  <dc:subject/>
  <dc:title>Diapositiva 1</dc:title>
</cp:coreProperties>
</file>